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0606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8227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30777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534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8135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31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2218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0313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2157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3343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9699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1C0221-8D5B-4B15-A8B1-7CD5F8B682AD}" type="datetimeFigureOut">
              <a:rPr lang="zh-CN" altLang="en-US" smtClean="0"/>
              <a:t>2020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A254A-327A-4299-8E0D-259DDF3CA2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5843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4" b="1565"/>
          <a:stretch/>
        </p:blipFill>
        <p:spPr>
          <a:xfrm>
            <a:off x="1571222" y="339528"/>
            <a:ext cx="8834907" cy="5301418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3099658" y="5923139"/>
            <a:ext cx="50396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mo case of Lenke 5C AIS (UEV=T10, UIV=T11)</a:t>
            </a:r>
            <a:endParaRPr lang="zh-CN" altLang="zh-CN" sz="20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13410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矩形 10"/>
          <p:cNvSpPr/>
          <p:nvPr/>
        </p:nvSpPr>
        <p:spPr>
          <a:xfrm>
            <a:off x="3391997" y="5835262"/>
            <a:ext cx="45470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rst case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rwent surgery for </a:t>
            </a:r>
            <a:r>
              <a:rPr lang="en-US" altLang="zh-CN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yringomyelia</a:t>
            </a:r>
            <a:endParaRPr lang="zh-CN" altLang="zh-CN" sz="20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548" y="389026"/>
            <a:ext cx="11284627" cy="53303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5794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/>
          <p:cNvSpPr/>
          <p:nvPr/>
        </p:nvSpPr>
        <p:spPr>
          <a:xfrm>
            <a:off x="3131872" y="6076831"/>
            <a:ext cx="4861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cond case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rwent surgery for </a:t>
            </a:r>
            <a:r>
              <a:rPr lang="en-US" altLang="zh-CN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yringomyelia</a:t>
            </a:r>
            <a:endParaRPr lang="zh-CN" altLang="zh-CN" sz="20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6028" y="553792"/>
            <a:ext cx="10312350" cy="53361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73990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矩形 10"/>
          <p:cNvSpPr/>
          <p:nvPr/>
        </p:nvSpPr>
        <p:spPr>
          <a:xfrm>
            <a:off x="3263373" y="5719352"/>
            <a:ext cx="46240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ird case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rwent surgery for </a:t>
            </a:r>
            <a:r>
              <a:rPr lang="en-US" altLang="zh-CN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yringomyelia</a:t>
            </a:r>
            <a:endParaRPr lang="zh-CN" altLang="zh-CN" sz="20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646" y="463639"/>
            <a:ext cx="10445508" cy="4962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97540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/>
        </p:nvSpPr>
        <p:spPr>
          <a:xfrm>
            <a:off x="1456656" y="5740151"/>
            <a:ext cx="953663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The patient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in syringomyelia group had postoperative </a:t>
            </a:r>
            <a:r>
              <a:rPr lang="en-US" altLang="zh-CN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transient mild numbness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</a:rPr>
              <a:t>in left lower extremity. </a:t>
            </a:r>
            <a:endParaRPr lang="zh-CN" altLang="en-US" dirty="0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9531" y="399245"/>
            <a:ext cx="10710884" cy="49541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6821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44</Words>
  <Application>Microsoft Office PowerPoint</Application>
  <PresentationFormat>宽屏</PresentationFormat>
  <Paragraphs>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eng</dc:creator>
  <cp:lastModifiedBy>Feng</cp:lastModifiedBy>
  <cp:revision>14</cp:revision>
  <dcterms:created xsi:type="dcterms:W3CDTF">2020-07-29T15:40:25Z</dcterms:created>
  <dcterms:modified xsi:type="dcterms:W3CDTF">2020-08-01T14:31:56Z</dcterms:modified>
</cp:coreProperties>
</file>